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wdp" ContentType="image/vnd.ms-photo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9" r:id="rId4"/>
    <p:sldId id="258" r:id="rId5"/>
  </p:sldIdLst>
  <p:sldSz cx="7559675" cy="10439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50" d="100"/>
          <a:sy n="50" d="100"/>
        </p:scale>
        <p:origin x="-3832" y="-112"/>
      </p:cViewPr>
      <p:guideLst>
        <p:guide orient="horz" pos="3288"/>
        <p:guide pos="238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printerSettings" Target="printerSettings/printerSettings1.bin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08486"/>
            <a:ext cx="6425724" cy="3634458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483102"/>
            <a:ext cx="5669756" cy="2520438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9F8F31-B911-4060-A904-EE04D86836F7}" type="datetimeFigureOut">
              <a:rPr lang="en-GB" smtClean="0"/>
              <a:t>08/12/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8AD62-58C7-4373-B636-CB9B536C49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90405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9F8F31-B911-4060-A904-EE04D86836F7}" type="datetimeFigureOut">
              <a:rPr lang="en-GB" smtClean="0"/>
              <a:t>08/12/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8AD62-58C7-4373-B636-CB9B536C49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50386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55801"/>
            <a:ext cx="1630055" cy="884690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55801"/>
            <a:ext cx="4795669" cy="884690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9F8F31-B911-4060-A904-EE04D86836F7}" type="datetimeFigureOut">
              <a:rPr lang="en-GB" smtClean="0"/>
              <a:t>08/12/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8AD62-58C7-4373-B636-CB9B536C49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630434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9F8F31-B911-4060-A904-EE04D86836F7}" type="datetimeFigureOut">
              <a:rPr lang="en-GB" smtClean="0"/>
              <a:t>08/12/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8AD62-58C7-4373-B636-CB9B536C49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93480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02603"/>
            <a:ext cx="6520220" cy="4342500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6986185"/>
            <a:ext cx="6520220" cy="2283618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9F8F31-B911-4060-A904-EE04D86836F7}" type="datetimeFigureOut">
              <a:rPr lang="en-GB" smtClean="0"/>
              <a:t>08/12/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8AD62-58C7-4373-B636-CB9B536C49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95222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779007"/>
            <a:ext cx="3212862" cy="66237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779007"/>
            <a:ext cx="3212862" cy="66237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9F8F31-B911-4060-A904-EE04D86836F7}" type="datetimeFigureOut">
              <a:rPr lang="en-GB" smtClean="0"/>
              <a:t>08/12/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8AD62-58C7-4373-B636-CB9B536C49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77404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55804"/>
            <a:ext cx="6520220" cy="201780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559104"/>
            <a:ext cx="3198096" cy="1254177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813281"/>
            <a:ext cx="3198096" cy="56087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559104"/>
            <a:ext cx="3213847" cy="1254177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813281"/>
            <a:ext cx="3213847" cy="56087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9F8F31-B911-4060-A904-EE04D86836F7}" type="datetimeFigureOut">
              <a:rPr lang="en-GB" smtClean="0"/>
              <a:t>08/12/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8AD62-58C7-4373-B636-CB9B536C49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17758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9F8F31-B911-4060-A904-EE04D86836F7}" type="datetimeFigureOut">
              <a:rPr lang="en-GB" smtClean="0"/>
              <a:t>08/12/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8AD62-58C7-4373-B636-CB9B536C49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49803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9F8F31-B911-4060-A904-EE04D86836F7}" type="datetimeFigureOut">
              <a:rPr lang="en-GB" smtClean="0"/>
              <a:t>08/12/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8AD62-58C7-4373-B636-CB9B536C49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62882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95960"/>
            <a:ext cx="2438192" cy="2435860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03083"/>
            <a:ext cx="3827085" cy="7418740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131820"/>
            <a:ext cx="2438192" cy="5802084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9F8F31-B911-4060-A904-EE04D86836F7}" type="datetimeFigureOut">
              <a:rPr lang="en-GB" smtClean="0"/>
              <a:t>08/12/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8AD62-58C7-4373-B636-CB9B536C49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77241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95960"/>
            <a:ext cx="2438192" cy="2435860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03083"/>
            <a:ext cx="3827085" cy="7418740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131820"/>
            <a:ext cx="2438192" cy="5802084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9F8F31-B911-4060-A904-EE04D86836F7}" type="datetimeFigureOut">
              <a:rPr lang="en-GB" smtClean="0"/>
              <a:t>08/12/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8AD62-58C7-4373-B636-CB9B536C49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91716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55804"/>
            <a:ext cx="6520220" cy="20178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779007"/>
            <a:ext cx="6520220" cy="66237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675780"/>
            <a:ext cx="1700927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9F8F31-B911-4060-A904-EE04D86836F7}" type="datetimeFigureOut">
              <a:rPr lang="en-GB" smtClean="0"/>
              <a:t>08/12/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675780"/>
            <a:ext cx="2551390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675780"/>
            <a:ext cx="1700927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58AD62-58C7-4373-B636-CB9B536C49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32649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microsoft.com/office/2007/relationships/hdphoto" Target="../media/hdphoto5.wdp"/><Relationship Id="rId12" Type="http://schemas.openxmlformats.org/officeDocument/2006/relationships/image" Target="../media/image6.png"/><Relationship Id="rId13" Type="http://schemas.microsoft.com/office/2007/relationships/hdphoto" Target="../media/hdphoto6.wdp"/><Relationship Id="rId14" Type="http://schemas.openxmlformats.org/officeDocument/2006/relationships/image" Target="../media/image7.png"/><Relationship Id="rId15" Type="http://schemas.microsoft.com/office/2007/relationships/hdphoto" Target="../media/hdphoto7.wdp"/><Relationship Id="rId16" Type="http://schemas.openxmlformats.org/officeDocument/2006/relationships/image" Target="../media/image8.png"/><Relationship Id="rId17" Type="http://schemas.microsoft.com/office/2007/relationships/hdphoto" Target="../media/hdphoto8.wdp"/><Relationship Id="rId18" Type="http://schemas.openxmlformats.org/officeDocument/2006/relationships/image" Target="../media/image9.png"/><Relationship Id="rId19" Type="http://schemas.microsoft.com/office/2007/relationships/hdphoto" Target="../media/hdphoto9.wdp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Relationship Id="rId3" Type="http://schemas.microsoft.com/office/2007/relationships/hdphoto" Target="../media/hdphoto1.wdp"/><Relationship Id="rId4" Type="http://schemas.openxmlformats.org/officeDocument/2006/relationships/image" Target="../media/image2.png"/><Relationship Id="rId5" Type="http://schemas.microsoft.com/office/2007/relationships/hdphoto" Target="../media/hdphoto2.wdp"/><Relationship Id="rId6" Type="http://schemas.openxmlformats.org/officeDocument/2006/relationships/image" Target="../media/image3.png"/><Relationship Id="rId7" Type="http://schemas.microsoft.com/office/2007/relationships/hdphoto" Target="../media/hdphoto3.wdp"/><Relationship Id="rId8" Type="http://schemas.openxmlformats.org/officeDocument/2006/relationships/image" Target="../media/image4.png"/><Relationship Id="rId9" Type="http://schemas.microsoft.com/office/2007/relationships/hdphoto" Target="../media/hdphoto4.wdp"/><Relationship Id="rId10" Type="http://schemas.openxmlformats.org/officeDocument/2006/relationships/image" Target="../media/image5.png"/></Relationships>
</file>

<file path=ppt/slides/_rels/slide2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5.png"/><Relationship Id="rId12" Type="http://schemas.microsoft.com/office/2007/relationships/hdphoto" Target="../media/hdphoto14.wdp"/><Relationship Id="rId13" Type="http://schemas.openxmlformats.org/officeDocument/2006/relationships/image" Target="../media/image16.png"/><Relationship Id="rId14" Type="http://schemas.microsoft.com/office/2007/relationships/hdphoto" Target="../media/hdphoto15.wdp"/><Relationship Id="rId15" Type="http://schemas.openxmlformats.org/officeDocument/2006/relationships/image" Target="../media/image17.png"/><Relationship Id="rId16" Type="http://schemas.microsoft.com/office/2007/relationships/hdphoto" Target="../media/hdphoto16.wdp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0.png"/><Relationship Id="rId3" Type="http://schemas.microsoft.com/office/2007/relationships/hdphoto" Target="../media/hdphoto10.wdp"/><Relationship Id="rId4" Type="http://schemas.openxmlformats.org/officeDocument/2006/relationships/image" Target="../media/image11.png"/><Relationship Id="rId5" Type="http://schemas.microsoft.com/office/2007/relationships/hdphoto" Target="../media/hdphoto11.wdp"/><Relationship Id="rId6" Type="http://schemas.openxmlformats.org/officeDocument/2006/relationships/image" Target="../media/image12.png"/><Relationship Id="rId7" Type="http://schemas.microsoft.com/office/2007/relationships/hdphoto" Target="../media/hdphoto12.wdp"/><Relationship Id="rId8" Type="http://schemas.openxmlformats.org/officeDocument/2006/relationships/image" Target="../media/image13.png"/><Relationship Id="rId9" Type="http://schemas.openxmlformats.org/officeDocument/2006/relationships/image" Target="../media/image14.png"/><Relationship Id="rId10" Type="http://schemas.microsoft.com/office/2007/relationships/hdphoto" Target="../media/hdphoto13.wdp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4" Type="http://schemas.openxmlformats.org/officeDocument/2006/relationships/image" Target="../media/image20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8.png"/></Relationships>
</file>

<file path=ppt/slides/_rels/slide4.xml.rels><?xml version="1.0" encoding="UTF-8" standalone="yes"?>
<Relationships xmlns="http://schemas.openxmlformats.org/package/2006/relationships"><Relationship Id="rId11" Type="http://schemas.microsoft.com/office/2007/relationships/hdphoto" Target="../media/hdphoto21.wdp"/><Relationship Id="rId12" Type="http://schemas.openxmlformats.org/officeDocument/2006/relationships/image" Target="../media/image26.png"/><Relationship Id="rId13" Type="http://schemas.microsoft.com/office/2007/relationships/hdphoto" Target="../media/hdphoto22.wdp"/><Relationship Id="rId14" Type="http://schemas.openxmlformats.org/officeDocument/2006/relationships/image" Target="../media/image27.png"/><Relationship Id="rId15" Type="http://schemas.openxmlformats.org/officeDocument/2006/relationships/image" Target="../media/image28.png"/><Relationship Id="rId16" Type="http://schemas.microsoft.com/office/2007/relationships/hdphoto" Target="../media/hdphoto23.wdp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1.png"/><Relationship Id="rId3" Type="http://schemas.microsoft.com/office/2007/relationships/hdphoto" Target="../media/hdphoto17.wdp"/><Relationship Id="rId4" Type="http://schemas.openxmlformats.org/officeDocument/2006/relationships/image" Target="../media/image22.png"/><Relationship Id="rId5" Type="http://schemas.microsoft.com/office/2007/relationships/hdphoto" Target="../media/hdphoto18.wdp"/><Relationship Id="rId6" Type="http://schemas.openxmlformats.org/officeDocument/2006/relationships/image" Target="../media/image23.png"/><Relationship Id="rId7" Type="http://schemas.microsoft.com/office/2007/relationships/hdphoto" Target="../media/hdphoto19.wdp"/><Relationship Id="rId8" Type="http://schemas.openxmlformats.org/officeDocument/2006/relationships/image" Target="../media/image24.png"/><Relationship Id="rId9" Type="http://schemas.microsoft.com/office/2007/relationships/hdphoto" Target="../media/hdphoto20.wdp"/><Relationship Id="rId10" Type="http://schemas.openxmlformats.org/officeDocument/2006/relationships/image" Target="../media/image2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6CCFC3FB-A4F8-4B97-90FC-DA92CECD184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-25000"/>
                    </a14:imgEffect>
                    <a14:imgEffect>
                      <a14:brightnessContrast bright="-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93668" y="3443293"/>
            <a:ext cx="1116000" cy="82737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90B6136C-866A-43A5-A8CD-8CF8C09BFB35}"/>
              </a:ext>
            </a:extLst>
          </p:cNvPr>
          <p:cNvSpPr txBox="1"/>
          <p:nvPr/>
        </p:nvSpPr>
        <p:spPr>
          <a:xfrm>
            <a:off x="1295394" y="3738567"/>
            <a:ext cx="24431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THBS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9C68C92A-79FD-4A5E-B8EC-967AEA714C2C}"/>
              </a:ext>
            </a:extLst>
          </p:cNvPr>
          <p:cNvSpPr txBox="1"/>
          <p:nvPr/>
        </p:nvSpPr>
        <p:spPr>
          <a:xfrm>
            <a:off x="1295394" y="2719390"/>
            <a:ext cx="24431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COL1A1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xmlns="" id="{562CB0AF-ABB0-4C5D-99EE-75D25BF8C1F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93668" y="1485908"/>
            <a:ext cx="1116000" cy="89280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xmlns="" id="{21380843-885C-4F74-89C3-882F663ABB90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93668" y="7315198"/>
            <a:ext cx="1116000" cy="640328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xmlns="" id="{4D6D527B-C207-4F44-96F7-8891E762E3DD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93668" y="6529390"/>
            <a:ext cx="1116000" cy="646105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xmlns="" id="{4613D004-3D1F-43A6-A7FC-C325515D1F66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93668" y="2543178"/>
            <a:ext cx="1116000" cy="777818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xmlns="" id="{5FFAEDA9-C131-4858-B1B8-7B8255624E03}"/>
              </a:ext>
            </a:extLst>
          </p:cNvPr>
          <p:cNvSpPr txBox="1"/>
          <p:nvPr/>
        </p:nvSpPr>
        <p:spPr>
          <a:xfrm>
            <a:off x="1295394" y="1800232"/>
            <a:ext cx="244316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FN1</a:t>
            </a:r>
          </a:p>
          <a:p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xmlns="" id="{162F8DC7-5DD8-42AF-8181-2E8E54DC6E80}"/>
              </a:ext>
            </a:extLst>
          </p:cNvPr>
          <p:cNvSpPr txBox="1"/>
          <p:nvPr/>
        </p:nvSpPr>
        <p:spPr>
          <a:xfrm>
            <a:off x="1295394" y="6762752"/>
            <a:ext cx="24431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αSMA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xmlns="" id="{E0453019-281A-4CC7-9E68-7271FB9B7FD7}"/>
              </a:ext>
            </a:extLst>
          </p:cNvPr>
          <p:cNvSpPr txBox="1"/>
          <p:nvPr/>
        </p:nvSpPr>
        <p:spPr>
          <a:xfrm>
            <a:off x="1295394" y="7400923"/>
            <a:ext cx="24431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TAGLN2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xmlns="" id="{D0F0211E-66F7-4A87-9A56-43E6EEF8EF83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93668" y="5862234"/>
            <a:ext cx="1116000" cy="566764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xmlns="" id="{55C394FB-CF50-436D-926F-51AA58F5FD9E}"/>
              </a:ext>
            </a:extLst>
          </p:cNvPr>
          <p:cNvSpPr txBox="1"/>
          <p:nvPr/>
        </p:nvSpPr>
        <p:spPr>
          <a:xfrm>
            <a:off x="1295394" y="5929317"/>
            <a:ext cx="24431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LOX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xmlns="" id="{D408DD9F-6D36-4BB2-85FA-CD1771A4EB9A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-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93668" y="4400551"/>
            <a:ext cx="1116000" cy="523837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xmlns="" id="{DA6C57AF-99A5-4A75-9FEA-20F74E161F1C}"/>
              </a:ext>
            </a:extLst>
          </p:cNvPr>
          <p:cNvSpPr txBox="1"/>
          <p:nvPr/>
        </p:nvSpPr>
        <p:spPr>
          <a:xfrm>
            <a:off x="1295394" y="4433887"/>
            <a:ext cx="24431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TNC</a:t>
            </a: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xmlns="" id="{2241A840-43D6-44A1-A55C-CB637AF62711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-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93668" y="5031631"/>
            <a:ext cx="1116000" cy="688515"/>
          </a:xfrm>
          <a:prstGeom prst="rect">
            <a:avLst/>
          </a:prstGeom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xmlns="" id="{61D59109-A9B6-4994-9976-0ACD051A1573}"/>
              </a:ext>
            </a:extLst>
          </p:cNvPr>
          <p:cNvSpPr txBox="1"/>
          <p:nvPr/>
        </p:nvSpPr>
        <p:spPr>
          <a:xfrm>
            <a:off x="1295394" y="5267328"/>
            <a:ext cx="24431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LOXL2</a:t>
            </a:r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xmlns="" id="{16E68105-03B5-4568-8D2B-803109B93547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-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93668" y="8068186"/>
            <a:ext cx="1116000" cy="659869"/>
          </a:xfrm>
          <a:prstGeom prst="rect">
            <a:avLst/>
          </a:prstGeom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xmlns="" id="{BFA62487-052E-414D-9B5B-A31ADE7DF444}"/>
              </a:ext>
            </a:extLst>
          </p:cNvPr>
          <p:cNvSpPr txBox="1"/>
          <p:nvPr/>
        </p:nvSpPr>
        <p:spPr>
          <a:xfrm>
            <a:off x="1295394" y="8153398"/>
            <a:ext cx="24431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HSP60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2B8765BF-8FBB-4F66-A217-0CC6D4705F32}"/>
              </a:ext>
            </a:extLst>
          </p:cNvPr>
          <p:cNvSpPr txBox="1"/>
          <p:nvPr/>
        </p:nvSpPr>
        <p:spPr>
          <a:xfrm rot="16200000">
            <a:off x="-1142998" y="-216533"/>
            <a:ext cx="30575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miR-neg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xmlns="" id="{A4D723B8-DC1A-40A3-BED6-5E879901D698}"/>
              </a:ext>
            </a:extLst>
          </p:cNvPr>
          <p:cNvSpPr txBox="1"/>
          <p:nvPr/>
        </p:nvSpPr>
        <p:spPr>
          <a:xfrm rot="16200000">
            <a:off x="-776284" y="-216533"/>
            <a:ext cx="30575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miR-143-3p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xmlns="" id="{D0440025-A730-4767-8288-BCD192F2E99E}"/>
              </a:ext>
            </a:extLst>
          </p:cNvPr>
          <p:cNvSpPr txBox="1"/>
          <p:nvPr/>
        </p:nvSpPr>
        <p:spPr>
          <a:xfrm rot="16200000">
            <a:off x="-423857" y="-216533"/>
            <a:ext cx="30575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miR-145-5p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AAF6E809-8A19-467A-A140-B371F86654B1}"/>
              </a:ext>
            </a:extLst>
          </p:cNvPr>
          <p:cNvSpPr txBox="1"/>
          <p:nvPr/>
        </p:nvSpPr>
        <p:spPr>
          <a:xfrm>
            <a:off x="357189" y="1709738"/>
            <a:ext cx="842961" cy="485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GB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xmlns="" id="{DB23B9F1-94C4-4544-BFF3-585D560D9B17}"/>
              </a:ext>
            </a:extLst>
          </p:cNvPr>
          <p:cNvSpPr txBox="1"/>
          <p:nvPr/>
        </p:nvSpPr>
        <p:spPr>
          <a:xfrm>
            <a:off x="438152" y="5876923"/>
            <a:ext cx="842961" cy="485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GB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xmlns="" id="{07DCB5A2-31ED-4770-B7BF-C82CDDDE0EC1}"/>
              </a:ext>
            </a:extLst>
          </p:cNvPr>
          <p:cNvSpPr txBox="1"/>
          <p:nvPr/>
        </p:nvSpPr>
        <p:spPr>
          <a:xfrm>
            <a:off x="238127" y="3638551"/>
            <a:ext cx="1004886" cy="55245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GB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xmlns="" id="{22A8351C-C8F9-4896-B8E6-3AAD9BEE6D11}"/>
              </a:ext>
            </a:extLst>
          </p:cNvPr>
          <p:cNvSpPr txBox="1"/>
          <p:nvPr/>
        </p:nvSpPr>
        <p:spPr>
          <a:xfrm>
            <a:off x="228598" y="4424361"/>
            <a:ext cx="1023938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GB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xmlns="" id="{395D2D74-871B-4D4F-89DC-C348EE966FAA}"/>
              </a:ext>
            </a:extLst>
          </p:cNvPr>
          <p:cNvSpPr txBox="1"/>
          <p:nvPr/>
        </p:nvSpPr>
        <p:spPr>
          <a:xfrm>
            <a:off x="500062" y="2647951"/>
            <a:ext cx="795337" cy="4333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GB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xmlns="" id="{F2B9F769-91A8-4885-BF5A-C572A717B92D}"/>
              </a:ext>
            </a:extLst>
          </p:cNvPr>
          <p:cNvSpPr txBox="1"/>
          <p:nvPr/>
        </p:nvSpPr>
        <p:spPr>
          <a:xfrm>
            <a:off x="261939" y="6577013"/>
            <a:ext cx="1004886" cy="55245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GB" dirty="0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xmlns="" id="{4F52E194-CFCF-488D-9EF4-DEA4B0C63D4A}"/>
              </a:ext>
            </a:extLst>
          </p:cNvPr>
          <p:cNvSpPr txBox="1"/>
          <p:nvPr/>
        </p:nvSpPr>
        <p:spPr>
          <a:xfrm>
            <a:off x="276227" y="8091488"/>
            <a:ext cx="1004886" cy="55245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GB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xmlns="" id="{C5F83C8B-6D00-43CD-B599-351E88E363F7}"/>
              </a:ext>
            </a:extLst>
          </p:cNvPr>
          <p:cNvSpPr txBox="1"/>
          <p:nvPr/>
        </p:nvSpPr>
        <p:spPr>
          <a:xfrm>
            <a:off x="442912" y="5291139"/>
            <a:ext cx="828675" cy="3047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GB" dirty="0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xmlns="" id="{186FDFF9-004F-48B6-9F1B-324B2E1F55E3}"/>
              </a:ext>
            </a:extLst>
          </p:cNvPr>
          <p:cNvSpPr txBox="1"/>
          <p:nvPr/>
        </p:nvSpPr>
        <p:spPr>
          <a:xfrm>
            <a:off x="279689" y="7621734"/>
            <a:ext cx="904873" cy="18876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0A909C51-D486-4611-B58F-22756568897E}"/>
              </a:ext>
            </a:extLst>
          </p:cNvPr>
          <p:cNvSpPr txBox="1"/>
          <p:nvPr/>
        </p:nvSpPr>
        <p:spPr>
          <a:xfrm>
            <a:off x="0" y="0"/>
            <a:ext cx="25336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3C:</a:t>
            </a:r>
          </a:p>
        </p:txBody>
      </p:sp>
    </p:spTree>
    <p:extLst>
      <p:ext uri="{BB962C8B-B14F-4D97-AF65-F5344CB8AC3E}">
        <p14:creationId xmlns:p14="http://schemas.microsoft.com/office/powerpoint/2010/main" val="15130459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C2A142A6-BEC5-4969-8946-CB3A5D1EEC6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36537" y="2067878"/>
            <a:ext cx="1116000" cy="344557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9A88D5B5-B264-4015-8AED-E6D16A3BFF0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36537" y="1663065"/>
            <a:ext cx="1116000" cy="288118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xmlns="" id="{2D930ECA-98F3-4E2F-B26A-59E32427BB9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36537" y="4487228"/>
            <a:ext cx="1116000" cy="231696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xmlns="" id="{AF764E27-456D-450F-BD85-706AD27C222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36537" y="3601402"/>
            <a:ext cx="1116000" cy="437886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xmlns="" id="{504EFCF9-F681-4126-996D-29A9301F34BA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-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36537" y="2839402"/>
            <a:ext cx="1116000" cy="266788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AF3D1746-3511-4312-9220-BD85E7392D25}"/>
              </a:ext>
            </a:extLst>
          </p:cNvPr>
          <p:cNvSpPr txBox="1"/>
          <p:nvPr/>
        </p:nvSpPr>
        <p:spPr>
          <a:xfrm>
            <a:off x="1306830" y="2842260"/>
            <a:ext cx="127158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THBS1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xmlns="" id="{28274BBF-321B-4271-8D68-E3DC24A71DFA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-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36537" y="4187190"/>
            <a:ext cx="1116000" cy="139500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xmlns="" id="{EBD58179-4FE3-4893-B72A-ACA04D6D3BFC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-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36537" y="3215640"/>
            <a:ext cx="1116000" cy="277406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xmlns="" id="{A7401882-A3B3-471D-B1B0-BC155F55C5D7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-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36537" y="2530614"/>
            <a:ext cx="1116000" cy="206473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xmlns="" id="{BDFA65B5-5622-4CE0-8416-E2C9340ABAC6}"/>
              </a:ext>
            </a:extLst>
          </p:cNvPr>
          <p:cNvSpPr txBox="1"/>
          <p:nvPr/>
        </p:nvSpPr>
        <p:spPr>
          <a:xfrm>
            <a:off x="1306830" y="1651636"/>
            <a:ext cx="127158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pERK1/2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xmlns="" id="{B95394F0-35FE-4307-AB8C-6C0DFB73A399}"/>
              </a:ext>
            </a:extLst>
          </p:cNvPr>
          <p:cNvSpPr txBox="1"/>
          <p:nvPr/>
        </p:nvSpPr>
        <p:spPr>
          <a:xfrm>
            <a:off x="1306830" y="2104074"/>
            <a:ext cx="127158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ERK2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xmlns="" id="{967DC084-E776-4152-850A-77F570D1B948}"/>
              </a:ext>
            </a:extLst>
          </p:cNvPr>
          <p:cNvSpPr txBox="1"/>
          <p:nvPr/>
        </p:nvSpPr>
        <p:spPr>
          <a:xfrm>
            <a:off x="1306830" y="2499361"/>
            <a:ext cx="127158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FN1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xmlns="" id="{F9D1B379-D5CA-4C04-BB4A-98417BAE969F}"/>
              </a:ext>
            </a:extLst>
          </p:cNvPr>
          <p:cNvSpPr txBox="1"/>
          <p:nvPr/>
        </p:nvSpPr>
        <p:spPr>
          <a:xfrm>
            <a:off x="1306830" y="3666173"/>
            <a:ext cx="127158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MLC2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xmlns="" id="{AABEE407-D558-40F3-BA81-5996F6D46AE6}"/>
              </a:ext>
            </a:extLst>
          </p:cNvPr>
          <p:cNvSpPr txBox="1"/>
          <p:nvPr/>
        </p:nvSpPr>
        <p:spPr>
          <a:xfrm>
            <a:off x="1306830" y="4461511"/>
            <a:ext cx="127158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HSP60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xmlns="" id="{1DB43839-9E7E-4E7F-82F3-78253009B329}"/>
              </a:ext>
            </a:extLst>
          </p:cNvPr>
          <p:cNvSpPr txBox="1"/>
          <p:nvPr/>
        </p:nvSpPr>
        <p:spPr>
          <a:xfrm>
            <a:off x="1306830" y="4085272"/>
            <a:ext cx="127158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SMA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xmlns="" id="{C6148DAD-7409-4A48-BEF2-F0AC993E11D1}"/>
              </a:ext>
            </a:extLst>
          </p:cNvPr>
          <p:cNvSpPr txBox="1"/>
          <p:nvPr/>
        </p:nvSpPr>
        <p:spPr>
          <a:xfrm>
            <a:off x="1306830" y="3223259"/>
            <a:ext cx="127158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LOXL2</a:t>
            </a: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xmlns="" id="{C4102447-3E89-45F9-84BC-7C35C41FF11C}"/>
              </a:ext>
            </a:extLst>
          </p:cNvPr>
          <p:cNvSpPr/>
          <p:nvPr/>
        </p:nvSpPr>
        <p:spPr>
          <a:xfrm>
            <a:off x="403860" y="2255520"/>
            <a:ext cx="929640" cy="14478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xmlns="" id="{5E7608F4-9513-4F58-9CC2-C9199C79ADD5}"/>
              </a:ext>
            </a:extLst>
          </p:cNvPr>
          <p:cNvSpPr/>
          <p:nvPr/>
        </p:nvSpPr>
        <p:spPr>
          <a:xfrm>
            <a:off x="396240" y="4191000"/>
            <a:ext cx="944880" cy="12954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xmlns="" id="{2476C4C3-AF55-4EC1-9DEC-064AAD264022}"/>
              </a:ext>
            </a:extLst>
          </p:cNvPr>
          <p:cNvSpPr/>
          <p:nvPr/>
        </p:nvSpPr>
        <p:spPr>
          <a:xfrm>
            <a:off x="411480" y="3840480"/>
            <a:ext cx="853440" cy="18288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xmlns="" id="{004240E0-A7FA-411E-B3EF-7C2204706159}"/>
              </a:ext>
            </a:extLst>
          </p:cNvPr>
          <p:cNvSpPr/>
          <p:nvPr/>
        </p:nvSpPr>
        <p:spPr>
          <a:xfrm>
            <a:off x="396240" y="3261360"/>
            <a:ext cx="944880" cy="21336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xmlns="" id="{E3D4D78C-FD2F-4C4C-A875-EA2D802AF5DC}"/>
              </a:ext>
            </a:extLst>
          </p:cNvPr>
          <p:cNvSpPr/>
          <p:nvPr/>
        </p:nvSpPr>
        <p:spPr>
          <a:xfrm>
            <a:off x="411480" y="2552700"/>
            <a:ext cx="944880" cy="21336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xmlns="" id="{C45199DA-9DEF-4EE7-8C3F-CE34C69E0F6F}"/>
              </a:ext>
            </a:extLst>
          </p:cNvPr>
          <p:cNvSpPr txBox="1"/>
          <p:nvPr/>
        </p:nvSpPr>
        <p:spPr>
          <a:xfrm rot="16200000">
            <a:off x="-293370" y="935876"/>
            <a:ext cx="127158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LNA Ctrl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xmlns="" id="{4A91CF07-CC2B-48B2-B905-201B83FD1090}"/>
              </a:ext>
            </a:extLst>
          </p:cNvPr>
          <p:cNvSpPr txBox="1"/>
          <p:nvPr/>
        </p:nvSpPr>
        <p:spPr>
          <a:xfrm rot="16200000">
            <a:off x="-87630" y="935876"/>
            <a:ext cx="127158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BRAFi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xmlns="" id="{65783002-C316-458E-BF76-54C8ACCDEC26}"/>
              </a:ext>
            </a:extLst>
          </p:cNvPr>
          <p:cNvSpPr txBox="1"/>
          <p:nvPr/>
        </p:nvSpPr>
        <p:spPr>
          <a:xfrm rot="16200000">
            <a:off x="-47805" y="754721"/>
            <a:ext cx="16338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BRAFi LNA-143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xmlns="" id="{52892486-EDAD-4949-8F8F-2873FE39DE2A}"/>
              </a:ext>
            </a:extLst>
          </p:cNvPr>
          <p:cNvSpPr txBox="1"/>
          <p:nvPr/>
        </p:nvSpPr>
        <p:spPr>
          <a:xfrm rot="16200000">
            <a:off x="173175" y="754721"/>
            <a:ext cx="16338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BRAFi LNA-145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xmlns="" id="{CDA3705C-AD3C-4A07-A1E4-CAF38ADF2B41}"/>
              </a:ext>
            </a:extLst>
          </p:cNvPr>
          <p:cNvSpPr txBox="1"/>
          <p:nvPr/>
        </p:nvSpPr>
        <p:spPr>
          <a:xfrm rot="16200000">
            <a:off x="371295" y="754721"/>
            <a:ext cx="16338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BRAFi LNA-143/145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xmlns="" id="{3F08FF65-543F-4C12-8715-AA859557D2E4}"/>
              </a:ext>
            </a:extLst>
          </p:cNvPr>
          <p:cNvSpPr txBox="1"/>
          <p:nvPr/>
        </p:nvSpPr>
        <p:spPr>
          <a:xfrm>
            <a:off x="-11907" y="-18348"/>
            <a:ext cx="24003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3D:</a:t>
            </a:r>
          </a:p>
        </p:txBody>
      </p:sp>
    </p:spTree>
    <p:extLst>
      <p:ext uri="{BB962C8B-B14F-4D97-AF65-F5344CB8AC3E}">
        <p14:creationId xmlns:p14="http://schemas.microsoft.com/office/powerpoint/2010/main" val="30442134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BDAAEC9F-F522-4022-BC76-0A967BF7234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8589" y="841774"/>
            <a:ext cx="1677988" cy="125849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4E69D156-73DA-4B05-8483-0ADFAB853E10}"/>
              </a:ext>
            </a:extLst>
          </p:cNvPr>
          <p:cNvSpPr txBox="1"/>
          <p:nvPr/>
        </p:nvSpPr>
        <p:spPr>
          <a:xfrm>
            <a:off x="0" y="0"/>
            <a:ext cx="26146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3F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BE9F27A3-3896-4A8B-A591-DC45F208CB34}"/>
              </a:ext>
            </a:extLst>
          </p:cNvPr>
          <p:cNvSpPr txBox="1"/>
          <p:nvPr/>
        </p:nvSpPr>
        <p:spPr>
          <a:xfrm>
            <a:off x="100016" y="614363"/>
            <a:ext cx="9572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miR-neg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BBCC4BE4-B0B7-4622-B32C-11DE344D72B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99497" y="849392"/>
            <a:ext cx="1677600" cy="125820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6ED98E75-9B05-4906-A0BA-ADBC516A5D50}"/>
              </a:ext>
            </a:extLst>
          </p:cNvPr>
          <p:cNvSpPr txBox="1"/>
          <p:nvPr/>
        </p:nvSpPr>
        <p:spPr>
          <a:xfrm>
            <a:off x="1866904" y="614363"/>
            <a:ext cx="9572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miR-143-3p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xmlns="" id="{5C40F933-C4EC-4C88-975C-E7CA17F15A5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74520" y="845582"/>
            <a:ext cx="1677600" cy="1258200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8DBC6458-4D0B-4368-9CE0-38810F198C64}"/>
              </a:ext>
            </a:extLst>
          </p:cNvPr>
          <p:cNvSpPr txBox="1"/>
          <p:nvPr/>
        </p:nvSpPr>
        <p:spPr>
          <a:xfrm>
            <a:off x="3528064" y="614363"/>
            <a:ext cx="9572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miR-145-5p</a:t>
            </a:r>
          </a:p>
        </p:txBody>
      </p:sp>
    </p:spTree>
    <p:extLst>
      <p:ext uri="{BB962C8B-B14F-4D97-AF65-F5344CB8AC3E}">
        <p14:creationId xmlns:p14="http://schemas.microsoft.com/office/powerpoint/2010/main" val="61021785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>
            <a:extLst>
              <a:ext uri="{FF2B5EF4-FFF2-40B4-BE49-F238E27FC236}">
                <a16:creationId xmlns:a16="http://schemas.microsoft.com/office/drawing/2014/main" xmlns="" id="{90C692EC-0FE9-4B8F-82EB-D08043E2521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-50000"/>
                    </a14:imgEffect>
                    <a14:imgEffect>
                      <a14:brightnessContrast bright="-20000" contrast="-40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 bwMode="auto">
          <a:xfrm>
            <a:off x="210370" y="1349271"/>
            <a:ext cx="1116000" cy="51814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" name="Picture 3">
            <a:extLst>
              <a:ext uri="{FF2B5EF4-FFF2-40B4-BE49-F238E27FC236}">
                <a16:creationId xmlns:a16="http://schemas.microsoft.com/office/drawing/2014/main" xmlns="" id="{1B1B3AC2-152E-476A-A912-1E54DE645D5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-40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 bwMode="auto">
          <a:xfrm>
            <a:off x="210370" y="1961030"/>
            <a:ext cx="1116000" cy="35946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5A0559DE-DE00-49DD-97E2-530B24734B9F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10370" y="3976090"/>
            <a:ext cx="1116000" cy="67683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39756565-AF2D-4309-85B8-082AAA2E545F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10370" y="3510015"/>
            <a:ext cx="1116000" cy="401276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xmlns="" id="{C7E4D77E-0B1E-4215-BD7B-562D855E4E28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10370" y="2827985"/>
            <a:ext cx="1116000" cy="61147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4DE54703-216F-4B19-A06A-01348DD9D4CF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10370" y="5501572"/>
            <a:ext cx="1116000" cy="233909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xmlns="" id="{5981DA55-B005-44A4-B2A9-90571BB8FA8A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r="341" b="14882"/>
          <a:stretch/>
        </p:blipFill>
        <p:spPr>
          <a:xfrm>
            <a:off x="210370" y="2409196"/>
            <a:ext cx="1116000" cy="350993"/>
          </a:xfrm>
          <a:prstGeom prst="rect">
            <a:avLst/>
          </a:prstGeom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xmlns="" id="{6A2BB2E4-4020-46A1-B242-658DE9FAA0E5}"/>
              </a:ext>
            </a:extLst>
          </p:cNvPr>
          <p:cNvSpPr/>
          <p:nvPr/>
        </p:nvSpPr>
        <p:spPr>
          <a:xfrm>
            <a:off x="552450" y="1516380"/>
            <a:ext cx="609600" cy="23812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xmlns="" id="{04CD28A9-1306-4EA0-9EC2-C63E54DFCC81}"/>
              </a:ext>
            </a:extLst>
          </p:cNvPr>
          <p:cNvSpPr/>
          <p:nvPr/>
        </p:nvSpPr>
        <p:spPr>
          <a:xfrm>
            <a:off x="419100" y="2916556"/>
            <a:ext cx="800100" cy="24765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5E99128C-6CBB-4CD4-B3C4-66EB379EFA9C}"/>
              </a:ext>
            </a:extLst>
          </p:cNvPr>
          <p:cNvSpPr txBox="1"/>
          <p:nvPr/>
        </p:nvSpPr>
        <p:spPr>
          <a:xfrm>
            <a:off x="1257300" y="1516380"/>
            <a:ext cx="7810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MITF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54D2D32A-1BF1-4001-A714-640DD801389B}"/>
              </a:ext>
            </a:extLst>
          </p:cNvPr>
          <p:cNvSpPr txBox="1"/>
          <p:nvPr/>
        </p:nvSpPr>
        <p:spPr>
          <a:xfrm>
            <a:off x="1257300" y="2011680"/>
            <a:ext cx="7810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AXL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985DD6DB-97F3-456F-9FB1-D2D23829F175}"/>
              </a:ext>
            </a:extLst>
          </p:cNvPr>
          <p:cNvSpPr txBox="1"/>
          <p:nvPr/>
        </p:nvSpPr>
        <p:spPr>
          <a:xfrm>
            <a:off x="1257300" y="2437130"/>
            <a:ext cx="7810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PDGFRβ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3E37CD47-A271-4613-9246-EDF0748022C7}"/>
              </a:ext>
            </a:extLst>
          </p:cNvPr>
          <p:cNvSpPr txBox="1"/>
          <p:nvPr/>
        </p:nvSpPr>
        <p:spPr>
          <a:xfrm>
            <a:off x="1257300" y="2976880"/>
            <a:ext cx="7810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EGFR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EF5374E9-65EF-41E0-A44D-21E0B374AFBB}"/>
              </a:ext>
            </a:extLst>
          </p:cNvPr>
          <p:cNvSpPr txBox="1"/>
          <p:nvPr/>
        </p:nvSpPr>
        <p:spPr>
          <a:xfrm>
            <a:off x="1257300" y="3554730"/>
            <a:ext cx="7810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NGFR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D67CAD41-F3DB-4637-9544-BE515EC70797}"/>
              </a:ext>
            </a:extLst>
          </p:cNvPr>
          <p:cNvSpPr txBox="1"/>
          <p:nvPr/>
        </p:nvSpPr>
        <p:spPr>
          <a:xfrm>
            <a:off x="1257300" y="4030980"/>
            <a:ext cx="7810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SOX9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0E6AA046-F6B1-42C1-8ABA-60B442DCE695}"/>
              </a:ext>
            </a:extLst>
          </p:cNvPr>
          <p:cNvSpPr txBox="1"/>
          <p:nvPr/>
        </p:nvSpPr>
        <p:spPr>
          <a:xfrm>
            <a:off x="1257300" y="4922097"/>
            <a:ext cx="7810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SOX10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A5E014B5-FA36-46FE-90BE-CC195AE822C4}"/>
              </a:ext>
            </a:extLst>
          </p:cNvPr>
          <p:cNvSpPr txBox="1"/>
          <p:nvPr/>
        </p:nvSpPr>
        <p:spPr>
          <a:xfrm>
            <a:off x="1257300" y="5489365"/>
            <a:ext cx="7810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HSP60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F04A8F7C-0630-41EB-8502-BA7CA49D2F03}"/>
              </a:ext>
            </a:extLst>
          </p:cNvPr>
          <p:cNvSpPr txBox="1"/>
          <p:nvPr/>
        </p:nvSpPr>
        <p:spPr>
          <a:xfrm rot="16200000">
            <a:off x="-858979" y="-296889"/>
            <a:ext cx="30575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miR-neg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xmlns="" id="{00E2AB57-29B4-4A17-82DD-BF2737597E2A}"/>
              </a:ext>
            </a:extLst>
          </p:cNvPr>
          <p:cNvSpPr txBox="1"/>
          <p:nvPr/>
        </p:nvSpPr>
        <p:spPr>
          <a:xfrm rot="16200000">
            <a:off x="-658520" y="-296889"/>
            <a:ext cx="30575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miR-143-3p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AA8D996F-EBBB-4ECA-8E0A-805B39019619}"/>
              </a:ext>
            </a:extLst>
          </p:cNvPr>
          <p:cNvSpPr txBox="1"/>
          <p:nvPr/>
        </p:nvSpPr>
        <p:spPr>
          <a:xfrm rot="16200000">
            <a:off x="-451564" y="-296889"/>
            <a:ext cx="30575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miR-145-5p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3A89E4F9-2425-4458-AB36-0DBB289D2AB5}"/>
              </a:ext>
            </a:extLst>
          </p:cNvPr>
          <p:cNvSpPr txBox="1"/>
          <p:nvPr/>
        </p:nvSpPr>
        <p:spPr>
          <a:xfrm>
            <a:off x="0" y="0"/>
            <a:ext cx="30937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3G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AAFA2FDD-C915-4FB7-9F2B-6B4FFF99FAA3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-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06903" y="4740275"/>
            <a:ext cx="1116000" cy="530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21307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93</Words>
  <Application>Microsoft Macintosh PowerPoint</Application>
  <PresentationFormat>Personnalisé</PresentationFormat>
  <Paragraphs>43</Paragraphs>
  <Slides>4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5" baseType="lpstr">
      <vt:lpstr>Office Theme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rena.diazzi1@gmail.com</dc:creator>
  <cp:lastModifiedBy>Sophie Tartare-Deckert</cp:lastModifiedBy>
  <cp:revision>7</cp:revision>
  <dcterms:created xsi:type="dcterms:W3CDTF">2021-11-28T16:47:29Z</dcterms:created>
  <dcterms:modified xsi:type="dcterms:W3CDTF">2021-12-08T08:51:43Z</dcterms:modified>
</cp:coreProperties>
</file>